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13322300" cy="7921625"/>
  <p:notesSz cx="6858000" cy="9144000"/>
  <p:defaultTextStyle>
    <a:defPPr>
      <a:defRPr lang="en-US"/>
    </a:defPPr>
    <a:lvl1pPr marL="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7695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75390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6308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5078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38476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26171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413867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901562" algn="l" defTabSz="97539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>
          <p15:clr>
            <a:srgbClr val="A4A3A4"/>
          </p15:clr>
        </p15:guide>
        <p15:guide id="2" pos="41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906" y="78"/>
      </p:cViewPr>
      <p:guideLst>
        <p:guide orient="horz" pos="2495"/>
        <p:guide pos="41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179" y="2460845"/>
            <a:ext cx="11323954" cy="169801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98347" y="4488927"/>
            <a:ext cx="9325612" cy="20244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5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4329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4845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658670" y="317244"/>
            <a:ext cx="2997519" cy="67590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6120" y="317244"/>
            <a:ext cx="8770515" cy="67590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3885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0052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2374" y="5090389"/>
            <a:ext cx="11323954" cy="1573323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2374" y="3357530"/>
            <a:ext cx="11323954" cy="1732855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7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431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6119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72173" y="1848385"/>
            <a:ext cx="5884016" cy="5227906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8489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18" y="1773198"/>
            <a:ext cx="5886329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6118" y="2512188"/>
            <a:ext cx="5886329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67547" y="1773198"/>
            <a:ext cx="5888641" cy="738984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7695" indent="0">
              <a:buNone/>
              <a:defRPr sz="2100" b="1"/>
            </a:lvl2pPr>
            <a:lvl3pPr marL="975390" indent="0">
              <a:buNone/>
              <a:defRPr sz="1900" b="1"/>
            </a:lvl3pPr>
            <a:lvl4pPr marL="1463086" indent="0">
              <a:buNone/>
              <a:defRPr sz="1700" b="1"/>
            </a:lvl4pPr>
            <a:lvl5pPr marL="1950781" indent="0">
              <a:buNone/>
              <a:defRPr sz="1700" b="1"/>
            </a:lvl5pPr>
            <a:lvl6pPr marL="2438476" indent="0">
              <a:buNone/>
              <a:defRPr sz="1700" b="1"/>
            </a:lvl6pPr>
            <a:lvl7pPr marL="2926171" indent="0">
              <a:buNone/>
              <a:defRPr sz="1700" b="1"/>
            </a:lvl7pPr>
            <a:lvl8pPr marL="3413867" indent="0">
              <a:buNone/>
              <a:defRPr sz="1700" b="1"/>
            </a:lvl8pPr>
            <a:lvl9pPr marL="3901562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67547" y="2512188"/>
            <a:ext cx="5888641" cy="4564103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7787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64446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03196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6120" y="315404"/>
            <a:ext cx="4382943" cy="134227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8652" y="315403"/>
            <a:ext cx="7447536" cy="6760888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6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6120" y="1657680"/>
            <a:ext cx="4382943" cy="5418613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637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11268" y="5545148"/>
            <a:ext cx="7993380" cy="654635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11268" y="707818"/>
            <a:ext cx="7993380" cy="4752975"/>
          </a:xfrm>
        </p:spPr>
        <p:txBody>
          <a:bodyPr/>
          <a:lstStyle>
            <a:lvl1pPr marL="0" indent="0">
              <a:buNone/>
              <a:defRPr sz="3400"/>
            </a:lvl1pPr>
            <a:lvl2pPr marL="487695" indent="0">
              <a:buNone/>
              <a:defRPr sz="3000"/>
            </a:lvl2pPr>
            <a:lvl3pPr marL="975390" indent="0">
              <a:buNone/>
              <a:defRPr sz="2600"/>
            </a:lvl3pPr>
            <a:lvl4pPr marL="1463086" indent="0">
              <a:buNone/>
              <a:defRPr sz="2100"/>
            </a:lvl4pPr>
            <a:lvl5pPr marL="1950781" indent="0">
              <a:buNone/>
              <a:defRPr sz="2100"/>
            </a:lvl5pPr>
            <a:lvl6pPr marL="2438476" indent="0">
              <a:buNone/>
              <a:defRPr sz="2100"/>
            </a:lvl6pPr>
            <a:lvl7pPr marL="2926171" indent="0">
              <a:buNone/>
              <a:defRPr sz="2100"/>
            </a:lvl7pPr>
            <a:lvl8pPr marL="3413867" indent="0">
              <a:buNone/>
              <a:defRPr sz="2100"/>
            </a:lvl8pPr>
            <a:lvl9pPr marL="3901562" indent="0">
              <a:buNone/>
              <a:defRPr sz="21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11268" y="6199777"/>
            <a:ext cx="7993380" cy="929690"/>
          </a:xfrm>
        </p:spPr>
        <p:txBody>
          <a:bodyPr/>
          <a:lstStyle>
            <a:lvl1pPr marL="0" indent="0">
              <a:buNone/>
              <a:defRPr sz="1500"/>
            </a:lvl1pPr>
            <a:lvl2pPr marL="487695" indent="0">
              <a:buNone/>
              <a:defRPr sz="1300"/>
            </a:lvl2pPr>
            <a:lvl3pPr marL="975390" indent="0">
              <a:buNone/>
              <a:defRPr sz="1100"/>
            </a:lvl3pPr>
            <a:lvl4pPr marL="1463086" indent="0">
              <a:buNone/>
              <a:defRPr sz="1000"/>
            </a:lvl4pPr>
            <a:lvl5pPr marL="1950781" indent="0">
              <a:buNone/>
              <a:defRPr sz="1000"/>
            </a:lvl5pPr>
            <a:lvl6pPr marL="2438476" indent="0">
              <a:buNone/>
              <a:defRPr sz="1000"/>
            </a:lvl6pPr>
            <a:lvl7pPr marL="2926171" indent="0">
              <a:buNone/>
              <a:defRPr sz="1000"/>
            </a:lvl7pPr>
            <a:lvl8pPr marL="3413867" indent="0">
              <a:buNone/>
              <a:defRPr sz="1000"/>
            </a:lvl8pPr>
            <a:lvl9pPr marL="3901562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803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6122" y="317238"/>
            <a:ext cx="11990068" cy="1320271"/>
          </a:xfrm>
          <a:prstGeom prst="rect">
            <a:avLst/>
          </a:prstGeom>
        </p:spPr>
        <p:txBody>
          <a:bodyPr vert="horz" lIns="97539" tIns="48770" rIns="97539" bIns="4877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6122" y="1848385"/>
            <a:ext cx="11990068" cy="5227906"/>
          </a:xfrm>
          <a:prstGeom prst="rect">
            <a:avLst/>
          </a:prstGeom>
        </p:spPr>
        <p:txBody>
          <a:bodyPr vert="horz" lIns="97539" tIns="48770" rIns="97539" bIns="4877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6120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6B5B2-B8CC-473E-92F6-A8C6FB6782F7}" type="datetimeFigureOut">
              <a:rPr lang="en-IN" smtClean="0"/>
              <a:t>07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51792" y="7342173"/>
            <a:ext cx="4218728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547652" y="7342173"/>
            <a:ext cx="3108535" cy="421754"/>
          </a:xfrm>
          <a:prstGeom prst="rect">
            <a:avLst/>
          </a:prstGeom>
        </p:spPr>
        <p:txBody>
          <a:bodyPr vert="horz" lIns="97539" tIns="48770" rIns="97539" bIns="4877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A6906-8424-4520-AC35-7E38AD6A8B0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5126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75390" rtl="0" eaLnBrk="1" latinLnBrk="0" hangingPunct="1"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71" indent="-365771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92505" indent="-304810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3409" y="-17630"/>
            <a:ext cx="12996453" cy="7866874"/>
            <a:chOff x="73409" y="-17630"/>
            <a:chExt cx="12996453" cy="786687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409" y="-17630"/>
              <a:ext cx="4067461" cy="397844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409" y="3816796"/>
              <a:ext cx="4067461" cy="403244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97862" y="504428"/>
              <a:ext cx="4572000" cy="72008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08421" y="3511418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068862" y="3600772"/>
              <a:ext cx="3508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b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0763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75150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97862" y="7382583"/>
              <a:ext cx="350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5533" y="4215331"/>
            <a:ext cx="4123809" cy="3561905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271169" y="7428229"/>
            <a:ext cx="38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86593" y="3934451"/>
            <a:ext cx="36006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NNs ROC curve for  small independent validation dataset</a:t>
            </a:r>
            <a:endParaRPr lang="en-IN" sz="1100" b="1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32980" y="273939"/>
            <a:ext cx="4128704" cy="3606627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5087012" y="144388"/>
            <a:ext cx="2727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DNNs ROC curve for  internal evaluation</a:t>
            </a:r>
            <a:endParaRPr lang="en-IN" sz="1100" b="1" dirty="0"/>
          </a:p>
        </p:txBody>
      </p:sp>
    </p:spTree>
    <p:extLst>
      <p:ext uri="{BB962C8B-B14F-4D97-AF65-F5344CB8AC3E}">
        <p14:creationId xmlns:p14="http://schemas.microsoft.com/office/powerpoint/2010/main" val="2502348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655" y="665954"/>
            <a:ext cx="4274817" cy="415895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0910" y="665954"/>
            <a:ext cx="4320479" cy="43029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124421" y="288404"/>
            <a:ext cx="32649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DNNs  ROC curve for  large independent benchmark dataset</a:t>
            </a:r>
            <a:endParaRPr lang="en-IN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51333" y="371445"/>
            <a:ext cx="32649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Receiver operating  characteristic curve </a:t>
            </a:r>
            <a:endParaRPr lang="en-IN" sz="12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1389" y="774474"/>
            <a:ext cx="4392489" cy="714715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52438" y="468089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06791" y="473315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751415" y="732544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1975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8</TotalTime>
  <Words>44</Words>
  <Application>Microsoft Office PowerPoint</Application>
  <PresentationFormat>Custom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raj</dc:creator>
  <cp:lastModifiedBy>Neeraj</cp:lastModifiedBy>
  <cp:revision>46</cp:revision>
  <dcterms:created xsi:type="dcterms:W3CDTF">2021-04-11T13:24:53Z</dcterms:created>
  <dcterms:modified xsi:type="dcterms:W3CDTF">2021-09-06T19:09:34Z</dcterms:modified>
</cp:coreProperties>
</file>